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8E7065-E55E-4FAD-8344-E33A38B5A96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031D8B-814F-4A22-8FC5-B19060E2342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4F80E9-AE1C-4B1D-AB41-167E94CFCAC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3F79F1-1F11-48B4-929B-13ED3425FE5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6B22B6-F9C5-497F-B42C-024B1429D01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670C60-21F0-4C49-96AF-B8EFF440242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85C162-3EDD-4597-9980-4A251316C82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7BB9FC-3FAB-4FD3-A5D4-511E19800F8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370F71-967C-4528-83D1-516120C034F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D33A00-1BBC-419B-B680-5227AA34FD1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3EE644-98DC-44DB-9A2E-79E59CFCD2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354C5E-7DE0-47F2-AA22-803DC0AA7C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DCE889A-A327-4B98-8E1B-996B1B0148C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305720" y="417600"/>
            <a:ext cx="6310080" cy="1438200"/>
            <a:chOff x="1305720" y="417600"/>
            <a:chExt cx="6310080" cy="1438200"/>
          </a:xfrm>
        </p:grpSpPr>
        <p:sp>
          <p:nvSpPr>
            <p:cNvPr id="42" name=""/>
            <p:cNvSpPr/>
            <p:nvPr/>
          </p:nvSpPr>
          <p:spPr>
            <a:xfrm>
              <a:off x="1305720" y="1184760"/>
              <a:ext cx="782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RUNX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1332720" y="1523880"/>
              <a:ext cx="720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β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-actin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 rot="18900000">
              <a:off x="1953720" y="740520"/>
              <a:ext cx="7444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OV2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 rot="18900000">
              <a:off x="2487240" y="727920"/>
              <a:ext cx="8438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OV11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 rot="18900000">
              <a:off x="3206160" y="785160"/>
              <a:ext cx="6364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OV9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 rot="18900000">
              <a:off x="3845880" y="697680"/>
              <a:ext cx="912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OVCAR3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 rot="18900000">
              <a:off x="4529160" y="717120"/>
              <a:ext cx="8344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KOV3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 rot="18900000">
              <a:off x="5140080" y="723240"/>
              <a:ext cx="8344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OV2008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 rot="18900000">
              <a:off x="5798520" y="691560"/>
              <a:ext cx="803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2780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 rot="18900000">
              <a:off x="6404400" y="685440"/>
              <a:ext cx="884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2780cp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 rot="18900000">
              <a:off x="7074360" y="847440"/>
              <a:ext cx="506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C13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3" name="" descr=""/>
            <p:cNvPicPr/>
            <p:nvPr/>
          </p:nvPicPr>
          <p:blipFill>
            <a:blip r:embed="rId1"/>
            <a:stretch/>
          </p:blipFill>
          <p:spPr>
            <a:xfrm>
              <a:off x="2014560" y="1152720"/>
              <a:ext cx="5486400" cy="341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4" name="" descr=""/>
            <p:cNvPicPr/>
            <p:nvPr/>
          </p:nvPicPr>
          <p:blipFill>
            <a:blip r:embed="rId2"/>
            <a:stretch/>
          </p:blipFill>
          <p:spPr>
            <a:xfrm>
              <a:off x="2013120" y="1514520"/>
              <a:ext cx="5502240" cy="34128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55" name=""/>
          <p:cNvSpPr/>
          <p:nvPr/>
        </p:nvSpPr>
        <p:spPr>
          <a:xfrm>
            <a:off x="457200" y="5715000"/>
            <a:ext cx="868680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igure S4.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Western blot analysis of RUNX2 protein expression in different EOC cell lines. A. </a:t>
            </a:r>
            <a:r>
              <a:rPr b="0" lang="en-CA" sz="1400" spc="-1" strike="noStrike">
                <a:solidFill>
                  <a:srgbClr val="000000"/>
                </a:solidFill>
                <a:latin typeface="Arial"/>
              </a:rPr>
              <a:t>Displayed are images of representative results following Western blot analysis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. . B. Densitometric analysis (by bar graphs presentation) of RUNX2 protein expression levels.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β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-actin was used as a loading control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1315800" y="762120"/>
            <a:ext cx="358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1373040" y="2438280"/>
            <a:ext cx="358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8" name="" descr=""/>
          <p:cNvPicPr/>
          <p:nvPr/>
        </p:nvPicPr>
        <p:blipFill>
          <a:blip r:embed="rId3"/>
          <a:stretch/>
        </p:blipFill>
        <p:spPr>
          <a:xfrm>
            <a:off x="2133720" y="1828800"/>
            <a:ext cx="5181480" cy="3887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7-04T15:25:37Z</dcterms:created>
  <dc:creator>Qiang</dc:creator>
  <dc:description/>
  <dc:language>en-US</dc:language>
  <cp:lastModifiedBy>Dbatch</cp:lastModifiedBy>
  <dcterms:modified xsi:type="dcterms:W3CDTF">2013-09-10T16:30:43Z</dcterms:modified>
  <cp:revision>20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